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64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tags" Target="../tags/tag63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3899535" y="480060"/>
            <a:ext cx="8058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973580" y="5403215"/>
            <a:ext cx="5068570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sz="1600">
                <a:latin typeface="Times New Roman" panose="02020603050405020304" charset="0"/>
                <a:cs typeface="Times New Roman" panose="02020603050405020304" charset="0"/>
              </a:rPr>
              <a:t>F</a:t>
            </a:r>
            <a:r>
              <a:rPr lang="en-US" sz="1600">
                <a:latin typeface="Times New Roman" panose="02020603050405020304" charset="0"/>
                <a:cs typeface="Times New Roman" panose="02020603050405020304" charset="0"/>
              </a:rPr>
              <a:t>igA </a:t>
            </a:r>
            <a:r>
              <a:rPr sz="1600">
                <a:latin typeface="Times New Roman" panose="02020603050405020304" charset="0"/>
                <a:cs typeface="Times New Roman" panose="02020603050405020304" charset="0"/>
              </a:rPr>
              <a:t>Alignment of full-length B602L protein amino acid sequences of different genotypes of ASFV strains</a:t>
            </a:r>
            <a:endParaRPr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11455" y="1000125"/>
            <a:ext cx="7506970" cy="418973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7020" y="1374140"/>
            <a:ext cx="774065" cy="3582670"/>
          </a:xfrm>
          <a:prstGeom prst="rect">
            <a:avLst/>
          </a:prstGeom>
        </p:spPr>
      </p:pic>
      <p:cxnSp>
        <p:nvCxnSpPr>
          <p:cNvPr id="6" name="直接连接符 5"/>
          <p:cNvCxnSpPr/>
          <p:nvPr/>
        </p:nvCxnSpPr>
        <p:spPr>
          <a:xfrm>
            <a:off x="8895715" y="1453515"/>
            <a:ext cx="1270" cy="16256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 flipH="1">
            <a:off x="8892540" y="3163570"/>
            <a:ext cx="1905" cy="46926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>
            <a:off x="8895715" y="3710305"/>
            <a:ext cx="1270" cy="1085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>
            <a:off x="8895715" y="3903980"/>
            <a:ext cx="0" cy="24511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>
            <a:off x="8894445" y="4250690"/>
            <a:ext cx="1270" cy="1085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>
            <a:off x="8895080" y="4438650"/>
            <a:ext cx="1270" cy="1085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>
            <a:off x="8893175" y="4605020"/>
            <a:ext cx="1270" cy="1085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>
            <a:off x="8896985" y="4792345"/>
            <a:ext cx="1270" cy="1085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9110345" y="2135505"/>
            <a:ext cx="6965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GT </a:t>
            </a:r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Ⅱ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9105900" y="3256280"/>
            <a:ext cx="6965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GT Ⅰ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9105900" y="3580130"/>
            <a:ext cx="86487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GT </a:t>
            </a:r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Ⅲ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9110345" y="3903980"/>
            <a:ext cx="69659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GT </a:t>
            </a:r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Ⅴ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9110345" y="4144645"/>
            <a:ext cx="105918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GT </a:t>
            </a:r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Ⅷ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9110345" y="4354830"/>
            <a:ext cx="104902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GT </a:t>
            </a:r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Ⅸ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9110345" y="4520565"/>
            <a:ext cx="73025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GT </a:t>
            </a:r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Ⅹ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9110345" y="4709160"/>
            <a:ext cx="137287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GT </a:t>
            </a:r>
            <a:r>
              <a:rPr lang="en-US" altLang="zh-CN" sz="1200"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</a:rPr>
              <a:t>ⅩⅩ</a:t>
            </a:r>
            <a:endParaRPr lang="en-US" altLang="zh-CN" sz="1200">
              <a:latin typeface="Times New Roman" panose="02020603050405020304" charset="0"/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  <p:custDataLst>
      <p:tags r:id="rId3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COMMONDATA" val="eyJoZGlkIjoiZTNjNWE5N2UwODhlNzA5OWQ1MGVjNGI2NDhiMTBmMmY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7</Words>
  <Application>WPS 演示</Application>
  <PresentationFormat>宽屏</PresentationFormat>
  <Paragraphs>20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洋流飘。</cp:lastModifiedBy>
  <cp:revision>151</cp:revision>
  <dcterms:created xsi:type="dcterms:W3CDTF">2019-06-19T02:08:00Z</dcterms:created>
  <dcterms:modified xsi:type="dcterms:W3CDTF">2022-08-27T12:34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313</vt:lpwstr>
  </property>
  <property fmtid="{D5CDD505-2E9C-101B-9397-08002B2CF9AE}" pid="3" name="ICV">
    <vt:lpwstr>DD42712497C046D3ACBE04F353C4E7F5</vt:lpwstr>
  </property>
</Properties>
</file>